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1878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0/8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オブジェクト 27">
            <a:extLst>
              <a:ext uri="{FF2B5EF4-FFF2-40B4-BE49-F238E27FC236}">
                <a16:creationId xmlns:a16="http://schemas.microsoft.com/office/drawing/2014/main" id="{338DA8C3-5FA8-400B-A95B-0CE1308B22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952239"/>
              </p:ext>
            </p:extLst>
          </p:nvPr>
        </p:nvGraphicFramePr>
        <p:xfrm>
          <a:off x="4589281" y="1900881"/>
          <a:ext cx="4015167" cy="3091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Image" r:id="rId3" imgW="5358600" imgH="4126680" progId="Photoshop.Image.13">
                  <p:embed/>
                </p:oleObj>
              </mc:Choice>
              <mc:Fallback>
                <p:oleObj name="Image" r:id="rId3" imgW="5358600" imgH="41266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89281" y="1900881"/>
                        <a:ext cx="4015167" cy="3091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オブジェクト 26">
            <a:extLst>
              <a:ext uri="{FF2B5EF4-FFF2-40B4-BE49-F238E27FC236}">
                <a16:creationId xmlns:a16="http://schemas.microsoft.com/office/drawing/2014/main" id="{039CB294-A1BA-4280-B04F-DCCE0CDEC2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08706"/>
              </p:ext>
            </p:extLst>
          </p:nvPr>
        </p:nvGraphicFramePr>
        <p:xfrm>
          <a:off x="484825" y="1900882"/>
          <a:ext cx="4015167" cy="3091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Image" r:id="rId5" imgW="5358600" imgH="4126680" progId="Photoshop.Image.13">
                  <p:embed/>
                </p:oleObj>
              </mc:Choice>
              <mc:Fallback>
                <p:oleObj name="Image" r:id="rId5" imgW="5358600" imgH="41266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4825" y="1900882"/>
                        <a:ext cx="4015167" cy="3091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テキスト ボックス 14"/>
          <p:cNvSpPr txBox="1"/>
          <p:nvPr/>
        </p:nvSpPr>
        <p:spPr>
          <a:xfrm>
            <a:off x="177533" y="164153"/>
            <a:ext cx="1762021" cy="456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nline Figur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619227C-765D-40EC-942C-3B296CC07053}"/>
              </a:ext>
            </a:extLst>
          </p:cNvPr>
          <p:cNvSpPr txBox="1"/>
          <p:nvPr/>
        </p:nvSpPr>
        <p:spPr>
          <a:xfrm>
            <a:off x="2922300" y="1429979"/>
            <a:ext cx="3262432" cy="456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odamine-phalloidin staining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091575" y="1959172"/>
            <a:ext cx="27671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9C2 overexpressing GJA+GJB4-WT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1536676-8E5B-403E-ADA6-6AE185E9AF95}"/>
              </a:ext>
            </a:extLst>
          </p:cNvPr>
          <p:cNvSpPr txBox="1"/>
          <p:nvPr/>
        </p:nvSpPr>
        <p:spPr>
          <a:xfrm>
            <a:off x="5067743" y="1959172"/>
            <a:ext cx="29867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9C2 overexpressing GJA+GJB4-E204A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937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lnSpc>
            <a:spcPct val="150000"/>
          </a:lnSpc>
          <a:defRPr kumimoji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15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テーマ</vt:lpstr>
      <vt:lpstr>Adobe Photoshop Imag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kamoto</dc:creator>
  <cp:lastModifiedBy>岡本　隆二</cp:lastModifiedBy>
  <cp:revision>33</cp:revision>
  <dcterms:created xsi:type="dcterms:W3CDTF">2017-03-09T11:37:26Z</dcterms:created>
  <dcterms:modified xsi:type="dcterms:W3CDTF">2020-08-16T02:55:27Z</dcterms:modified>
</cp:coreProperties>
</file>